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5" r:id="rId3"/>
    <p:sldId id="264" r:id="rId4"/>
    <p:sldId id="267" r:id="rId5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64" d="100"/>
          <a:sy n="64" d="100"/>
        </p:scale>
        <p:origin x="72" y="15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6A47CB3-7AC0-4B1C-8919-527569C5B13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C19D4D84-25F9-474B-B83E-7B0103DE002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038F862-9CCE-437F-8E7F-644C80D2FD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CFE01-F0CD-45D1-A970-BE8D0557322D}" type="datetimeFigureOut">
              <a:rPr lang="it-IT" smtClean="0"/>
              <a:t>04/02/20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309F00E-7A12-4DED-8F23-41BE9EFB8C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8AA266C-4DCD-4C52-BD75-A6ED436983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20A7D-2F6B-4BD0-A785-C85C54B4EE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659321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7A9C858-7F2A-44CD-B368-B6BA527DC1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6368C053-1417-4344-A3D9-7D951D53FD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A386F4B-32CC-4993-AE2B-4662AA1B04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CFE01-F0CD-45D1-A970-BE8D0557322D}" type="datetimeFigureOut">
              <a:rPr lang="it-IT" smtClean="0"/>
              <a:t>04/02/20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4A44A22-2144-440D-B1E5-5CCDAD8705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1CF142C-BB00-4EEE-A3F9-70E6A72298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20A7D-2F6B-4BD0-A785-C85C54B4EE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812721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9F39CB6C-C14A-4EE4-B318-B4F80AC9ED3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FBECFED6-81EE-4CE1-A241-2A88967DC5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EACA51D-3DEA-4276-9573-5F5B8F0669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CFE01-F0CD-45D1-A970-BE8D0557322D}" type="datetimeFigureOut">
              <a:rPr lang="it-IT" smtClean="0"/>
              <a:t>04/02/20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D21FA45-5818-4ABE-B65E-DE6FB4A04D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4A217EF-AAC0-4C00-B44E-A43471186A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20A7D-2F6B-4BD0-A785-C85C54B4EE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492069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51819C4-D857-40B1-9FE4-687B8585C4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33A6A82-0F24-465D-AFE3-D0297DDACE1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4B45D7F-B7D7-495B-BD66-BD139D14AA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CFE01-F0CD-45D1-A970-BE8D0557322D}" type="datetimeFigureOut">
              <a:rPr lang="it-IT" smtClean="0"/>
              <a:t>04/02/20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AD67A55-B3DD-4C55-8BA0-1EF1544BAC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69BA477-931A-43FF-BCFD-8C9AC14923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20A7D-2F6B-4BD0-A785-C85C54B4EE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14988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7B66777-4049-4AD6-B952-0A29C5459B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278DD52-9A8D-4B39-8176-42D82F8A73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54764E6-EECD-4537-B069-73A50DD905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CFE01-F0CD-45D1-A970-BE8D0557322D}" type="datetimeFigureOut">
              <a:rPr lang="it-IT" smtClean="0"/>
              <a:t>04/02/20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B4E7C9C-4C9A-4E1E-99EF-580EF4B6C7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A6CB947-BDE6-4C3E-BA85-C2A74D8206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20A7D-2F6B-4BD0-A785-C85C54B4EE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691772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EC4AD3D-ED48-4686-A962-F18C7B8B4E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78BC26F-E858-4AA3-858F-496BA84A849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85CFB30E-4EFF-4972-B275-86A20957E4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3630217-FFB1-412E-AE98-E8EFADF309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CFE01-F0CD-45D1-A970-BE8D0557322D}" type="datetimeFigureOut">
              <a:rPr lang="it-IT" smtClean="0"/>
              <a:t>04/02/2019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0CAA0FD-D908-46B5-8EAA-4888803C4E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54C73772-CE76-40B4-B66D-5EA172F0F2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20A7D-2F6B-4BD0-A785-C85C54B4EE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426340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0A4AE2C-3AF4-4B92-82E1-ADC1C417EA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98928AE3-0A60-4C3F-84BD-EA167614DF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14BC036E-1B75-4227-9800-1A9EF87A6A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37AD0339-07C4-40DF-86B7-E6C6C214A43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3994EABA-17B5-4451-A1A3-E3F8378F49A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8B5AA178-5F55-4B5A-8312-41CD248633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CFE01-F0CD-45D1-A970-BE8D0557322D}" type="datetimeFigureOut">
              <a:rPr lang="it-IT" smtClean="0"/>
              <a:t>04/02/2019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54BBC778-2B77-4ABE-9CF9-AF99C5243A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CDDB7DE9-7D47-44AB-BCD3-E5E25D52A7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20A7D-2F6B-4BD0-A785-C85C54B4EE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422334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3890183-D9AF-42BF-AA0B-86F297971D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8E729052-BA25-4472-A793-9E30BCC1B2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CFE01-F0CD-45D1-A970-BE8D0557322D}" type="datetimeFigureOut">
              <a:rPr lang="it-IT" smtClean="0"/>
              <a:t>04/02/2019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CE5C550D-03DA-471F-98C3-C01EEA9650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1301CD2E-EF7A-485A-B809-FC42FDA66A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20A7D-2F6B-4BD0-A785-C85C54B4EE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722009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E1F55203-7E58-4D94-A0BC-81ADC921BD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CFE01-F0CD-45D1-A970-BE8D0557322D}" type="datetimeFigureOut">
              <a:rPr lang="it-IT" smtClean="0"/>
              <a:t>04/02/2019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9E69A738-48BA-4FCA-82AC-C44D032657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5B1CBCBA-447A-4C96-9AEB-41A3521537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20A7D-2F6B-4BD0-A785-C85C54B4EE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060080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A1E53AA-F711-41AC-8E9D-856D80CE47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AB56272-DCB7-49F1-8674-1C8C90129BC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961D2A1-ED96-48B1-B00A-9FC94DC7B0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0EDE4DE-3125-465F-BB24-0E0616D8FE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CFE01-F0CD-45D1-A970-BE8D0557322D}" type="datetimeFigureOut">
              <a:rPr lang="it-IT" smtClean="0"/>
              <a:t>04/02/2019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E488657-313C-417B-95E1-2E7031EFE6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8C24721-FD2E-4891-B97E-5CFDB86A3F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20A7D-2F6B-4BD0-A785-C85C54B4EE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736246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70F74D7-E0C4-4FB6-BD8B-B798EBFBE1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C7F74C68-F1B6-4DFD-B0D8-B4B77126696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4EB918D5-C204-4011-AB91-50EF9D2FF0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C13F5CA-EA32-452A-BC0B-C9149143A4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CFE01-F0CD-45D1-A970-BE8D0557322D}" type="datetimeFigureOut">
              <a:rPr lang="it-IT" smtClean="0"/>
              <a:t>04/02/2019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C474B045-8810-428E-B9ED-ACDD4FC4AE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AF5439D-5D89-4671-94CF-04A5745CC9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20A7D-2F6B-4BD0-A785-C85C54B4EE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761404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38F6E3A1-80E7-4B2C-9A1F-83B8775F86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0F34696-34C3-451E-8E32-6E22C67DF0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3096A63-B63E-44D2-BD72-5DD55E138FA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BCFE01-F0CD-45D1-A970-BE8D0557322D}" type="datetimeFigureOut">
              <a:rPr lang="it-IT" smtClean="0"/>
              <a:t>04/02/20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8D9FFDC-E50D-444F-9B2D-6B5EBB80A11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09D07A1-84CA-4D9F-ADBE-D3BC4E2E1D2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520A7D-2F6B-4BD0-A785-C85C54B4EE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268654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715E85BC-E453-491B-B618-B8A59A46CCD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29446" y="1563462"/>
            <a:ext cx="6133108" cy="3731075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B5DD8E0D-B274-4F78-A470-2D0C089E4750}"/>
              </a:ext>
            </a:extLst>
          </p:cNvPr>
          <p:cNvSpPr txBox="1"/>
          <p:nvPr/>
        </p:nvSpPr>
        <p:spPr>
          <a:xfrm>
            <a:off x="374073" y="96982"/>
            <a:ext cx="24253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/>
              <a:t>Supplemental</a:t>
            </a:r>
            <a:r>
              <a:rPr lang="it-IT" dirty="0"/>
              <a:t> Figure 1</a:t>
            </a:r>
          </a:p>
        </p:txBody>
      </p:sp>
    </p:spTree>
    <p:extLst>
      <p:ext uri="{BB962C8B-B14F-4D97-AF65-F5344CB8AC3E}">
        <p14:creationId xmlns:p14="http://schemas.microsoft.com/office/powerpoint/2010/main" val="29029536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ggetto 5">
            <a:extLst>
              <a:ext uri="{FF2B5EF4-FFF2-40B4-BE49-F238E27FC236}">
                <a16:creationId xmlns:a16="http://schemas.microsoft.com/office/drawing/2014/main" id="{7BAA96E9-D8F9-4F8D-BD50-A389E62E8683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1636713" y="1208088"/>
          <a:ext cx="8661400" cy="44434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7" r:id="rId3" imgW="6804044" imgH="3457839" progId="Prism7.Document">
                  <p:embed/>
                </p:oleObj>
              </mc:Choice>
              <mc:Fallback>
                <p:oleObj name="Prism 7" r:id="rId3" imgW="6804044" imgH="3457839" progId="Prism7.Document">
                  <p:embed/>
                  <p:pic>
                    <p:nvPicPr>
                      <p:cNvPr id="6" name="Oggetto 5">
                        <a:extLst>
                          <a:ext uri="{FF2B5EF4-FFF2-40B4-BE49-F238E27FC236}">
                            <a16:creationId xmlns:a16="http://schemas.microsoft.com/office/drawing/2014/main" id="{7BAA96E9-D8F9-4F8D-BD50-A389E62E868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36713" y="1208088"/>
                        <a:ext cx="8661400" cy="44434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CasellaDiTesto 3">
            <a:extLst>
              <a:ext uri="{FF2B5EF4-FFF2-40B4-BE49-F238E27FC236}">
                <a16:creationId xmlns:a16="http://schemas.microsoft.com/office/drawing/2014/main" id="{6025FA22-75A6-4F15-A403-6709D60C368A}"/>
              </a:ext>
            </a:extLst>
          </p:cNvPr>
          <p:cNvSpPr txBox="1"/>
          <p:nvPr/>
        </p:nvSpPr>
        <p:spPr>
          <a:xfrm>
            <a:off x="374073" y="96982"/>
            <a:ext cx="24253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/>
              <a:t>Supplemental</a:t>
            </a:r>
            <a:r>
              <a:rPr lang="it-IT" dirty="0"/>
              <a:t> Figure 2</a:t>
            </a:r>
          </a:p>
        </p:txBody>
      </p:sp>
    </p:spTree>
    <p:extLst>
      <p:ext uri="{BB962C8B-B14F-4D97-AF65-F5344CB8AC3E}">
        <p14:creationId xmlns:p14="http://schemas.microsoft.com/office/powerpoint/2010/main" val="25901010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magine 5">
            <a:extLst>
              <a:ext uri="{FF2B5EF4-FFF2-40B4-BE49-F238E27FC236}">
                <a16:creationId xmlns:a16="http://schemas.microsoft.com/office/drawing/2014/main" id="{CAD5B9FE-2DA2-4516-BBB3-F510AABFC5D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48361" y="1097827"/>
            <a:ext cx="6137342" cy="4662345"/>
          </a:xfrm>
          <a:prstGeom prst="rect">
            <a:avLst/>
          </a:prstGeom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7139E5BB-B6A6-4F2D-A553-92BEAED9F50B}"/>
              </a:ext>
            </a:extLst>
          </p:cNvPr>
          <p:cNvSpPr txBox="1"/>
          <p:nvPr/>
        </p:nvSpPr>
        <p:spPr>
          <a:xfrm>
            <a:off x="374073" y="96982"/>
            <a:ext cx="24253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/>
              <a:t>Supplemental</a:t>
            </a:r>
            <a:r>
              <a:rPr lang="it-IT" dirty="0"/>
              <a:t> Figure 3</a:t>
            </a:r>
          </a:p>
        </p:txBody>
      </p:sp>
    </p:spTree>
    <p:extLst>
      <p:ext uri="{BB962C8B-B14F-4D97-AF65-F5344CB8AC3E}">
        <p14:creationId xmlns:p14="http://schemas.microsoft.com/office/powerpoint/2010/main" val="39419133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>
            <a:extLst>
              <a:ext uri="{FF2B5EF4-FFF2-40B4-BE49-F238E27FC236}">
                <a16:creationId xmlns:a16="http://schemas.microsoft.com/office/drawing/2014/main" id="{157DD7ED-D9B1-423A-80B4-2F895D99D25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77215" y="1310156"/>
            <a:ext cx="8237570" cy="4237688"/>
          </a:xfrm>
          <a:prstGeom prst="rect">
            <a:avLst/>
          </a:prstGeom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1517585C-E947-4F51-B4F8-A971D8EB9998}"/>
              </a:ext>
            </a:extLst>
          </p:cNvPr>
          <p:cNvSpPr txBox="1"/>
          <p:nvPr/>
        </p:nvSpPr>
        <p:spPr>
          <a:xfrm>
            <a:off x="374073" y="96982"/>
            <a:ext cx="24253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/>
              <a:t>Supplemental</a:t>
            </a:r>
            <a:r>
              <a:rPr lang="it-IT" dirty="0"/>
              <a:t> Figure 4</a:t>
            </a:r>
          </a:p>
        </p:txBody>
      </p:sp>
    </p:spTree>
    <p:extLst>
      <p:ext uri="{BB962C8B-B14F-4D97-AF65-F5344CB8AC3E}">
        <p14:creationId xmlns:p14="http://schemas.microsoft.com/office/powerpoint/2010/main" val="330036584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9</TotalTime>
  <Words>12</Words>
  <Application>Microsoft Office PowerPoint</Application>
  <PresentationFormat>Widescreen</PresentationFormat>
  <Paragraphs>4</Paragraphs>
  <Slides>4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ema di Office</vt:lpstr>
      <vt:lpstr>Prism 7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Domenico Luca Grieco</dc:creator>
  <cp:lastModifiedBy>Domenico Luca Grieco</cp:lastModifiedBy>
  <cp:revision>2</cp:revision>
  <dcterms:created xsi:type="dcterms:W3CDTF">2018-12-20T11:27:02Z</dcterms:created>
  <dcterms:modified xsi:type="dcterms:W3CDTF">2019-02-04T20:08:37Z</dcterms:modified>
</cp:coreProperties>
</file>